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0"/>
  </p:notesMasterIdLst>
  <p:sldIdLst>
    <p:sldId id="256" r:id="rId2"/>
    <p:sldId id="317" r:id="rId3"/>
    <p:sldId id="318" r:id="rId4"/>
    <p:sldId id="302" r:id="rId5"/>
    <p:sldId id="303" r:id="rId6"/>
    <p:sldId id="304" r:id="rId7"/>
    <p:sldId id="305" r:id="rId8"/>
    <p:sldId id="306" r:id="rId9"/>
    <p:sldId id="307" r:id="rId10"/>
    <p:sldId id="308" r:id="rId11"/>
    <p:sldId id="309" r:id="rId12"/>
    <p:sldId id="310" r:id="rId13"/>
    <p:sldId id="311" r:id="rId14"/>
    <p:sldId id="312" r:id="rId15"/>
    <p:sldId id="313" r:id="rId16"/>
    <p:sldId id="314" r:id="rId17"/>
    <p:sldId id="316" r:id="rId18"/>
    <p:sldId id="320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873FC9-48F1-734C-8C42-803C7686C76E}" v="3" dt="2024-01-19T20:52:30.8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9216"/>
    <p:restoredTop sz="91938"/>
  </p:normalViewPr>
  <p:slideViewPr>
    <p:cSldViewPr snapToGrid="0">
      <p:cViewPr varScale="1">
        <p:scale>
          <a:sx n="76" d="100"/>
          <a:sy n="76" d="100"/>
        </p:scale>
        <p:origin x="216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5/10/relationships/revisionInfo" Target="revisionInfo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ng, Liubin" userId="d32ea224-2658-4f36-b8db-2737dedd026c" providerId="ADAL" clId="{0D16CC1E-5347-DA40-B56B-04DF28A1538A}"/>
    <pc:docChg chg="custSel addSld modSld sldOrd">
      <pc:chgData name="Yang, Liubin" userId="d32ea224-2658-4f36-b8db-2737dedd026c" providerId="ADAL" clId="{0D16CC1E-5347-DA40-B56B-04DF28A1538A}" dt="2023-11-22T17:02:47.455" v="23" actId="12385"/>
      <pc:docMkLst>
        <pc:docMk/>
      </pc:docMkLst>
      <pc:sldChg chg="addSp delSp modSp new mod ord">
        <pc:chgData name="Yang, Liubin" userId="d32ea224-2658-4f36-b8db-2737dedd026c" providerId="ADAL" clId="{0D16CC1E-5347-DA40-B56B-04DF28A1538A}" dt="2023-11-22T17:02:47.455" v="23" actId="12385"/>
        <pc:sldMkLst>
          <pc:docMk/>
          <pc:sldMk cId="3728518524" sldId="317"/>
        </pc:sldMkLst>
        <pc:spChg chg="del">
          <ac:chgData name="Yang, Liubin" userId="d32ea224-2658-4f36-b8db-2737dedd026c" providerId="ADAL" clId="{0D16CC1E-5347-DA40-B56B-04DF28A1538A}" dt="2023-11-22T14:25:52.551" v="3" actId="478"/>
          <ac:spMkLst>
            <pc:docMk/>
            <pc:sldMk cId="3728518524" sldId="317"/>
            <ac:spMk id="2" creationId="{79DA4710-2621-401E-126B-A6C61F9CEF80}"/>
          </ac:spMkLst>
        </pc:spChg>
        <pc:spChg chg="del">
          <ac:chgData name="Yang, Liubin" userId="d32ea224-2658-4f36-b8db-2737dedd026c" providerId="ADAL" clId="{0D16CC1E-5347-DA40-B56B-04DF28A1538A}" dt="2023-11-22T14:25:50.843" v="2" actId="478"/>
          <ac:spMkLst>
            <pc:docMk/>
            <pc:sldMk cId="3728518524" sldId="317"/>
            <ac:spMk id="3" creationId="{94AA9343-63E5-146E-0CCF-B51138EF2A31}"/>
          </ac:spMkLst>
        </pc:spChg>
        <pc:graphicFrameChg chg="add mod modGraphic">
          <ac:chgData name="Yang, Liubin" userId="d32ea224-2658-4f36-b8db-2737dedd026c" providerId="ADAL" clId="{0D16CC1E-5347-DA40-B56B-04DF28A1538A}" dt="2023-11-22T17:02:47.455" v="23" actId="12385"/>
          <ac:graphicFrameMkLst>
            <pc:docMk/>
            <pc:sldMk cId="3728518524" sldId="317"/>
            <ac:graphicFrameMk id="4" creationId="{78C29BEF-1037-0448-69D3-37C3BEEDF971}"/>
          </ac:graphicFrameMkLst>
        </pc:graphicFrameChg>
      </pc:sldChg>
    </pc:docChg>
  </pc:docChgLst>
  <pc:docChgLst>
    <pc:chgData name="Yang, Liubin" userId="d32ea224-2658-4f36-b8db-2737dedd026c" providerId="ADAL" clId="{8C08D058-65D1-6D49-A37F-EFC5A124A765}"/>
    <pc:docChg chg="delSld">
      <pc:chgData name="Yang, Liubin" userId="d32ea224-2658-4f36-b8db-2737dedd026c" providerId="ADAL" clId="{8C08D058-65D1-6D49-A37F-EFC5A124A765}" dt="2023-11-16T14:29:13.628" v="0" actId="2696"/>
      <pc:docMkLst>
        <pc:docMk/>
      </pc:docMkLst>
      <pc:sldChg chg="del">
        <pc:chgData name="Yang, Liubin" userId="d32ea224-2658-4f36-b8db-2737dedd026c" providerId="ADAL" clId="{8C08D058-65D1-6D49-A37F-EFC5A124A765}" dt="2023-11-16T14:29:13.628" v="0" actId="2696"/>
        <pc:sldMkLst>
          <pc:docMk/>
          <pc:sldMk cId="1537744603" sldId="315"/>
        </pc:sldMkLst>
      </pc:sldChg>
    </pc:docChg>
  </pc:docChgLst>
  <pc:docChgLst>
    <pc:chgData name="Yang, Liubin" userId="d32ea224-2658-4f36-b8db-2737dedd026c" providerId="ADAL" clId="{3D873FC9-48F1-734C-8C42-803C7686C76E}"/>
    <pc:docChg chg="modSld">
      <pc:chgData name="Yang, Liubin" userId="d32ea224-2658-4f36-b8db-2737dedd026c" providerId="ADAL" clId="{3D873FC9-48F1-734C-8C42-803C7686C76E}" dt="2024-01-19T21:34:52.690" v="41" actId="20577"/>
      <pc:docMkLst>
        <pc:docMk/>
      </pc:docMkLst>
      <pc:sldChg chg="modSp mod">
        <pc:chgData name="Yang, Liubin" userId="d32ea224-2658-4f36-b8db-2737dedd026c" providerId="ADAL" clId="{3D873FC9-48F1-734C-8C42-803C7686C76E}" dt="2024-01-19T21:34:52.690" v="41" actId="20577"/>
        <pc:sldMkLst>
          <pc:docMk/>
          <pc:sldMk cId="3728518524" sldId="317"/>
        </pc:sldMkLst>
        <pc:graphicFrameChg chg="mod modGraphic">
          <ac:chgData name="Yang, Liubin" userId="d32ea224-2658-4f36-b8db-2737dedd026c" providerId="ADAL" clId="{3D873FC9-48F1-734C-8C42-803C7686C76E}" dt="2024-01-19T21:34:52.690" v="41" actId="20577"/>
          <ac:graphicFrameMkLst>
            <pc:docMk/>
            <pc:sldMk cId="3728518524" sldId="317"/>
            <ac:graphicFrameMk id="4" creationId="{78C29BEF-1037-0448-69D3-37C3BEEDF97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29E139-715E-0448-9164-C036BD691B9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93EC8E-1825-CA49-A956-3205D0BA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75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nal confusion matrix for each of </a:t>
            </a:r>
            <a:r>
              <a:rPr lang="en-US"/>
              <a:t>the algorithm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93EC8E-1825-CA49-A956-3205D0BA2B46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530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nal confusion matrix for each of </a:t>
            </a:r>
            <a:r>
              <a:rPr lang="en-US"/>
              <a:t>the algorithm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93EC8E-1825-CA49-A956-3205D0BA2B46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7239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852EF-45D6-8541-C0D5-5FCC182DDE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15EB06-3F25-E7DB-1566-B999106863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A2D344-D96F-B13F-A6E4-8049FE308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8AFEC4-8BD2-482B-5236-276097E2D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2F1C5-887C-F209-136F-14E184BC5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065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B2AE9-7652-167E-65EC-5B059094F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3AFBB9-CCE3-DF4C-0823-3D18DFFCCE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9D1EAA-C0CD-79FC-E94D-0AC17D255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FBF90-608A-A764-08EB-6332E9D1E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49615A-0825-697C-9756-7FF7E3E3B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763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70D5FB-7543-0E2D-517D-A24CAE77A5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77981B-A0D4-6E70-66BE-FC103C5E0E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77FADF-51E2-385E-DEE9-198A463D9C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7106D-B718-3CED-69A7-BBE28D13C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1E2100-D89A-C76C-CAE2-1E1148719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269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653CB-0643-0CD8-71A7-813D4A7165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9145C0-1923-DB2A-2384-D5346BDF3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BEA89-D6CA-DE6B-E52B-825DECD1A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34D733-4258-6A92-2B51-9801DB1A8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AAD46-5C83-4986-C2C4-6AB056FFC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586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70A55-AAE9-72FA-705C-ECD2861DB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9F4EE4-04AA-074B-4110-490A94ECEB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6C5E4E-FD3E-F312-CE01-68B036F7B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5F81A-5A37-7320-FF4E-0959A586B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430F4C-FE80-FDE2-E1B8-1500EB190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968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77B947-71DA-1CD7-7BCC-88C23417F8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646CE-09DD-D8BE-0774-55E1F32EA7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F50056-44F7-3814-C323-0BBD02A6C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6FC753-77A8-BA6A-83E5-51208A651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5BDCE3-9B9F-1AE6-3024-64DB0E209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5D3B70-EF66-019D-2417-34D7E0444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11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6D5CA-38C8-B470-BBEC-EEE47893D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4D12A0-79AE-9798-5DEE-1F8B88CAF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5D0742-54D9-843D-2132-E5CFFC7844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380DCF-68D6-B1FF-7381-A74A256921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E3FBD6-2BFC-5DD7-2799-1C1D9C6362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8B7F84-79F3-8269-2FBE-A3703D231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668563-868E-ACB2-8DE1-F46E0ED17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A7E437-1003-59E9-A145-84F567322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295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BD46A-91C0-4870-3DC5-2EF46219E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BC2902-C7CD-2033-B2FF-5B248CCF6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D4425B-8EE8-2CBC-901D-C1C83F5E1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2AF2A6-6D41-71F0-6249-D1C1BD37C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707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E5C5F3-657B-B2C8-A051-5EF5F6D86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8A51AE-8BF3-99BE-E511-D4914ACF5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40300C-AF98-4B12-DA02-F52A44998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76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70AD9-CEDD-7C37-113D-6911FA4EF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428CE5-D085-07F8-DE7E-AB9BEB6558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3233BD-9160-404A-6FFA-7AD8BCBE6F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52818A-8AF0-D330-4631-55861F947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11B8BD-F889-B02E-110A-AFDF698CF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1BF120-9B3E-38A9-8E9F-A1CDE46B1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9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DB5FAB-AC6C-14E8-D1B6-57691494B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566C47-98F2-47CC-660B-7ECA1E2499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BDE56C-3D21-64A3-ACB3-33B6D99933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70C0AC-FD42-EC79-BA59-0CC39E810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B36AD9-5B7C-207D-FC39-4F4AA2074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C55908-634E-693E-4EA5-E53E06589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878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DBAAC3-9A21-3D2B-6469-F838866F9A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E94CA0-9893-A01E-9FDD-F1B3960C9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79C741-848D-892F-8D13-634C42C28C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FBE1C-B17E-F447-AE5D-D9A1E169100A}" type="datetimeFigureOut">
              <a:rPr lang="en-US" smtClean="0"/>
              <a:t>1/19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113A6C-27C2-A9EA-42B3-20C13E013D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7C9CAC-7603-FEB8-1254-743020B699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9BC7B-E96E-C641-A878-079AE08A8C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883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BD321-A062-044B-A546-BFDB2BA1E73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upplemental File 1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C37587-E38F-0FD5-EFF6-76E58FF6DE4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186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41312-8784-C352-BB71-B4D4DF8C5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7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6098396C-DB4F-0AFA-9342-1AE901953CE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152650" y="2446280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3B1C569-5B44-9242-3F74-93AB80618743}"/>
              </a:ext>
            </a:extLst>
          </p:cNvPr>
          <p:cNvSpPr txBox="1"/>
          <p:nvPr/>
        </p:nvSpPr>
        <p:spPr>
          <a:xfrm>
            <a:off x="6089278" y="2419490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3          74.41</a:t>
            </a:r>
          </a:p>
          <a:p>
            <a:r>
              <a:rPr lang="en-US" sz="1350" dirty="0"/>
              <a:t>1     |        62          40.59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5         115.00</a:t>
            </a:r>
          </a:p>
          <a:p>
            <a:endParaRPr lang="en-US" sz="1350" dirty="0"/>
          </a:p>
          <a:p>
            <a:r>
              <a:rPr lang="en-US" sz="1350" dirty="0"/>
              <a:t>            chi2(1) =      18.89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0</a:t>
            </a:r>
          </a:p>
          <a:p>
            <a:endParaRPr lang="en-US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FBD2AC1-3003-9E8A-9DD8-7D43E1A8026E}"/>
              </a:ext>
            </a:extLst>
          </p:cNvPr>
          <p:cNvSpPr txBox="1"/>
          <p:nvPr/>
        </p:nvSpPr>
        <p:spPr>
          <a:xfrm>
            <a:off x="285750" y="247650"/>
            <a:ext cx="30168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6817870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97E01-E65B-5C26-C83D-C1EC93BC7B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8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12A1DC-DB9D-8267-7F6C-618C6E372E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2AF37E8-4ABC-DA1C-F9F9-ABBCFBC430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0774" y="2125266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01B9322-989C-B144-2567-6730535919FD}"/>
              </a:ext>
            </a:extLst>
          </p:cNvPr>
          <p:cNvSpPr txBox="1"/>
          <p:nvPr/>
        </p:nvSpPr>
        <p:spPr>
          <a:xfrm>
            <a:off x="5924551" y="1953972"/>
            <a:ext cx="4578723" cy="30008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350" dirty="0"/>
          </a:p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3          70.33</a:t>
            </a:r>
          </a:p>
          <a:p>
            <a:r>
              <a:rPr lang="en-US" sz="1350" dirty="0"/>
              <a:t>1     |        61          43.67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4         114.00</a:t>
            </a:r>
          </a:p>
          <a:p>
            <a:endParaRPr lang="en-US" sz="1350" dirty="0"/>
          </a:p>
          <a:p>
            <a:r>
              <a:rPr lang="en-US" sz="1350" dirty="0"/>
              <a:t>            chi2(1) =      11.68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6</a:t>
            </a:r>
          </a:p>
          <a:p>
            <a:endParaRPr lang="en-US" sz="135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208E7B5-06FA-497B-1466-F5C9B3E31D3B}"/>
              </a:ext>
            </a:extLst>
          </p:cNvPr>
          <p:cNvSpPr txBox="1"/>
          <p:nvPr/>
        </p:nvSpPr>
        <p:spPr>
          <a:xfrm>
            <a:off x="285750" y="247650"/>
            <a:ext cx="3321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18423049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86C5E-7002-D914-2189-FEC90AFF96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9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4B58DB-FE24-085E-FCA9-9B0C3EB58D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69385A0-0765-D3CA-3C09-1CE185570B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9750" y="2125266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1535824-646F-C265-7A43-119E8773795B}"/>
              </a:ext>
            </a:extLst>
          </p:cNvPr>
          <p:cNvSpPr txBox="1"/>
          <p:nvPr/>
        </p:nvSpPr>
        <p:spPr>
          <a:xfrm>
            <a:off x="5803528" y="2081037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1          70.10</a:t>
            </a:r>
          </a:p>
          <a:p>
            <a:r>
              <a:rPr lang="en-US" sz="1350" dirty="0"/>
              <a:t>1     |        62          42.90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3         113.00</a:t>
            </a:r>
          </a:p>
          <a:p>
            <a:endParaRPr lang="en-US" sz="1350" dirty="0"/>
          </a:p>
          <a:p>
            <a:r>
              <a:rPr lang="en-US" sz="1350" dirty="0"/>
              <a:t>            chi2(1) =      15.22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1</a:t>
            </a:r>
          </a:p>
          <a:p>
            <a:endParaRPr lang="en-US" sz="135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7DA6CF-BD5C-3A7D-B818-932DBD722602}"/>
              </a:ext>
            </a:extLst>
          </p:cNvPr>
          <p:cNvSpPr txBox="1"/>
          <p:nvPr/>
        </p:nvSpPr>
        <p:spPr>
          <a:xfrm>
            <a:off x="285750" y="247650"/>
            <a:ext cx="42511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7692389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050322-D502-B18F-20BE-5087740F8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M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419D97-E79F-F2A5-0F66-7029FD0A5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633BE3D-912E-5021-E755-A524D2A06A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6097" y="2057400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3AA63E7-E3D7-9BC0-0AD8-241E589FC6E1}"/>
              </a:ext>
            </a:extLst>
          </p:cNvPr>
          <p:cNvSpPr txBox="1"/>
          <p:nvPr/>
        </p:nvSpPr>
        <p:spPr>
          <a:xfrm>
            <a:off x="6254006" y="2057400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350" dirty="0"/>
          </a:p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49          68.47</a:t>
            </a:r>
          </a:p>
          <a:p>
            <a:r>
              <a:rPr lang="en-US" sz="1350" dirty="0"/>
              <a:t>1     |        62          42.53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1         111.00</a:t>
            </a:r>
          </a:p>
          <a:p>
            <a:endParaRPr lang="en-US" sz="1350" dirty="0"/>
          </a:p>
          <a:p>
            <a:r>
              <a:rPr lang="en-US" sz="1350" dirty="0"/>
              <a:t>            chi2(1) =      15.78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22D5F78-E7BB-4497-A591-DD598F251630}"/>
              </a:ext>
            </a:extLst>
          </p:cNvPr>
          <p:cNvSpPr txBox="1"/>
          <p:nvPr/>
        </p:nvSpPr>
        <p:spPr>
          <a:xfrm>
            <a:off x="285750" y="247650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48852943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2D586-C08D-691B-BEFE-759D840D7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SB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8D7432F-9DB4-5DE7-5652-0C0C3CD5C42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152650" y="2125266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0D163F7-CC90-F9FF-7682-966BE1049B22}"/>
              </a:ext>
            </a:extLst>
          </p:cNvPr>
          <p:cNvSpPr txBox="1"/>
          <p:nvPr/>
        </p:nvSpPr>
        <p:spPr>
          <a:xfrm>
            <a:off x="6096001" y="2044005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48          66.26</a:t>
            </a:r>
          </a:p>
          <a:p>
            <a:r>
              <a:rPr lang="en-US" sz="1350" dirty="0"/>
              <a:t>1     |        62          43.74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0         110.00</a:t>
            </a:r>
          </a:p>
          <a:p>
            <a:endParaRPr lang="en-US" sz="1350" dirty="0"/>
          </a:p>
          <a:p>
            <a:r>
              <a:rPr lang="en-US" sz="1350" dirty="0"/>
              <a:t>            chi2(1) =      13.95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2</a:t>
            </a:r>
          </a:p>
          <a:p>
            <a:endParaRPr lang="en-US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87CD799-BC1D-B4D1-94DB-99F6EB1A1BE3}"/>
              </a:ext>
            </a:extLst>
          </p:cNvPr>
          <p:cNvSpPr txBox="1"/>
          <p:nvPr/>
        </p:nvSpPr>
        <p:spPr>
          <a:xfrm>
            <a:off x="285750" y="247650"/>
            <a:ext cx="5790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8032295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0AD9B4-E53A-E0FF-C32D-D8BBECD84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B</a:t>
            </a:r>
            <a:endParaRPr lang="en-US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D7336DB5-9849-1E7C-F58B-8CC065A6AB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66430" y="1794515"/>
            <a:ext cx="5395292" cy="39238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13F57CB-6FE4-A8A5-1773-32CA77E9E32D}"/>
              </a:ext>
            </a:extLst>
          </p:cNvPr>
          <p:cNvSpPr txBox="1"/>
          <p:nvPr/>
        </p:nvSpPr>
        <p:spPr>
          <a:xfrm>
            <a:off x="7361723" y="2147882"/>
            <a:ext cx="3496049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46          54.08</a:t>
            </a:r>
          </a:p>
          <a:p>
            <a:r>
              <a:rPr lang="en-US" sz="1350" dirty="0"/>
              <a:t>1     |        59          50.92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05         105.00</a:t>
            </a:r>
          </a:p>
          <a:p>
            <a:endParaRPr lang="en-US" sz="1350" dirty="0"/>
          </a:p>
          <a:p>
            <a:r>
              <a:rPr lang="en-US" sz="1350" dirty="0"/>
              <a:t>            chi2(1) =       2.59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107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8F71AA5-6B8B-B86F-FFC9-583A520C2F50}"/>
              </a:ext>
            </a:extLst>
          </p:cNvPr>
          <p:cNvSpPr txBox="1"/>
          <p:nvPr/>
        </p:nvSpPr>
        <p:spPr>
          <a:xfrm>
            <a:off x="285750" y="247650"/>
            <a:ext cx="4828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N</a:t>
            </a:r>
          </a:p>
        </p:txBody>
      </p:sp>
    </p:spTree>
    <p:extLst>
      <p:ext uri="{BB962C8B-B14F-4D97-AF65-F5344CB8AC3E}">
        <p14:creationId xmlns:p14="http://schemas.microsoft.com/office/powerpoint/2010/main" val="10811405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D016B9-3B8C-F1C3-7749-4C0B6EFF4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EB</a:t>
            </a:r>
            <a:endParaRPr lang="en-US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0A8DDD93-F605-D1AE-78BB-2BA428C38D7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11456" y="2125266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D102A6C-AF91-E3E1-44B4-2331BC4D3F24}"/>
              </a:ext>
            </a:extLst>
          </p:cNvPr>
          <p:cNvSpPr txBox="1"/>
          <p:nvPr/>
        </p:nvSpPr>
        <p:spPr>
          <a:xfrm>
            <a:off x="6408647" y="2044005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27          25.04</a:t>
            </a:r>
          </a:p>
          <a:p>
            <a:r>
              <a:rPr lang="en-US" sz="1350" dirty="0"/>
              <a:t>1     |        39          40.96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 66          66.00</a:t>
            </a:r>
          </a:p>
          <a:p>
            <a:endParaRPr lang="en-US" sz="1350" dirty="0"/>
          </a:p>
          <a:p>
            <a:r>
              <a:rPr lang="en-US" sz="1350" dirty="0"/>
              <a:t>            chi2(1) =       0.27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6026</a:t>
            </a:r>
          </a:p>
          <a:p>
            <a:endParaRPr lang="en-US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1866C2F-F0DD-D8A1-41DA-F0597A63DBF1}"/>
              </a:ext>
            </a:extLst>
          </p:cNvPr>
          <p:cNvSpPr txBox="1"/>
          <p:nvPr/>
        </p:nvSpPr>
        <p:spPr>
          <a:xfrm>
            <a:off x="285750" y="247650"/>
            <a:ext cx="49084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40898529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F684D-559A-078C-7DCA-50A0CC2618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Content Placeholder 4" descr="Random Forest">
            <a:extLst>
              <a:ext uri="{FF2B5EF4-FFF2-40B4-BE49-F238E27FC236}">
                <a16:creationId xmlns:a16="http://schemas.microsoft.com/office/drawing/2014/main" id="{BA9C49E5-FFEA-CE35-01F7-FC6B7747F76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73145" y="2156853"/>
            <a:ext cx="3618106" cy="3097855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A059CD1-A125-2980-1AC1-29596BBF118A}"/>
              </a:ext>
            </a:extLst>
          </p:cNvPr>
          <p:cNvSpPr txBox="1"/>
          <p:nvPr/>
        </p:nvSpPr>
        <p:spPr>
          <a:xfrm>
            <a:off x="1383179" y="1787521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ogistic Regression</a:t>
            </a:r>
          </a:p>
        </p:txBody>
      </p:sp>
      <p:pic>
        <p:nvPicPr>
          <p:cNvPr id="8" name="Picture 7" descr="A screenshot of a computer&#10;&#10;Description automatically generated">
            <a:extLst>
              <a:ext uri="{FF2B5EF4-FFF2-40B4-BE49-F238E27FC236}">
                <a16:creationId xmlns:a16="http://schemas.microsoft.com/office/drawing/2014/main" id="{3460E979-1513-79DD-EFB7-F1DA735421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91250" y="2156854"/>
            <a:ext cx="3618105" cy="309785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554F3E2-2AC9-7838-7598-254B59E2C0D2}"/>
              </a:ext>
            </a:extLst>
          </p:cNvPr>
          <p:cNvSpPr txBox="1"/>
          <p:nvPr/>
        </p:nvSpPr>
        <p:spPr>
          <a:xfrm>
            <a:off x="5396529" y="178752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 descr="A screenshot of a computer&#10;&#10;Description automatically generated">
            <a:extLst>
              <a:ext uri="{FF2B5EF4-FFF2-40B4-BE49-F238E27FC236}">
                <a16:creationId xmlns:a16="http://schemas.microsoft.com/office/drawing/2014/main" id="{43796D54-FAB4-57BE-9FE0-AE78619084F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43083" y="2156853"/>
            <a:ext cx="3618104" cy="309785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92626F0-08F9-0601-490B-BAC5EF769E08}"/>
              </a:ext>
            </a:extLst>
          </p:cNvPr>
          <p:cNvSpPr txBox="1"/>
          <p:nvPr/>
        </p:nvSpPr>
        <p:spPr>
          <a:xfrm>
            <a:off x="8964712" y="1739104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ndom Fores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367BCC4-B2FD-88DF-7624-DD92C16B720F}"/>
              </a:ext>
            </a:extLst>
          </p:cNvPr>
          <p:cNvSpPr txBox="1"/>
          <p:nvPr/>
        </p:nvSpPr>
        <p:spPr>
          <a:xfrm>
            <a:off x="285750" y="247650"/>
            <a:ext cx="4235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39057964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A059CD1-A125-2980-1AC1-29596BBF118A}"/>
              </a:ext>
            </a:extLst>
          </p:cNvPr>
          <p:cNvSpPr txBox="1"/>
          <p:nvPr/>
        </p:nvSpPr>
        <p:spPr>
          <a:xfrm>
            <a:off x="1383179" y="1787521"/>
            <a:ext cx="2198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Logistic Regres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554F3E2-2AC9-7838-7598-254B59E2C0D2}"/>
              </a:ext>
            </a:extLst>
          </p:cNvPr>
          <p:cNvSpPr txBox="1"/>
          <p:nvPr/>
        </p:nvSpPr>
        <p:spPr>
          <a:xfrm>
            <a:off x="5396529" y="178752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2626F0-08F9-0601-490B-BAC5EF769E08}"/>
              </a:ext>
            </a:extLst>
          </p:cNvPr>
          <p:cNvSpPr txBox="1"/>
          <p:nvPr/>
        </p:nvSpPr>
        <p:spPr>
          <a:xfrm>
            <a:off x="9033976" y="1787521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andom Fores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367BCC4-B2FD-88DF-7624-DD92C16B720F}"/>
              </a:ext>
            </a:extLst>
          </p:cNvPr>
          <p:cNvSpPr txBox="1"/>
          <p:nvPr/>
        </p:nvSpPr>
        <p:spPr>
          <a:xfrm>
            <a:off x="285750" y="247650"/>
            <a:ext cx="4956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Q</a:t>
            </a:r>
          </a:p>
        </p:txBody>
      </p:sp>
      <p:pic>
        <p:nvPicPr>
          <p:cNvPr id="10" name="Picture 2">
            <a:extLst>
              <a:ext uri="{FF2B5EF4-FFF2-40B4-BE49-F238E27FC236}">
                <a16:creationId xmlns:a16="http://schemas.microsoft.com/office/drawing/2014/main" id="{010DAB40-E6EC-1D78-AC4B-28F03882501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50" y="2156854"/>
            <a:ext cx="3952670" cy="30978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>
            <a:extLst>
              <a:ext uri="{FF2B5EF4-FFF2-40B4-BE49-F238E27FC236}">
                <a16:creationId xmlns:a16="http://schemas.microsoft.com/office/drawing/2014/main" id="{3E7A635F-CB3E-540F-B1DB-85307FE172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78967" y="2156854"/>
            <a:ext cx="3952670" cy="30978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>
            <a:extLst>
              <a:ext uri="{FF2B5EF4-FFF2-40B4-BE49-F238E27FC236}">
                <a16:creationId xmlns:a16="http://schemas.microsoft.com/office/drawing/2014/main" id="{3ABF3304-8D71-F499-CDBE-7BD7EE4584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3034" y="2156854"/>
            <a:ext cx="3952670" cy="30978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021940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8C29BEF-1037-0448-69D3-37C3BEEDF9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4233263"/>
              </p:ext>
            </p:extLst>
          </p:nvPr>
        </p:nvGraphicFramePr>
        <p:xfrm>
          <a:off x="917470" y="614362"/>
          <a:ext cx="7415369" cy="562927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75558">
                  <a:extLst>
                    <a:ext uri="{9D8B030D-6E8A-4147-A177-3AD203B41FA5}">
                      <a16:colId xmlns:a16="http://schemas.microsoft.com/office/drawing/2014/main" val="316795699"/>
                    </a:ext>
                  </a:extLst>
                </a:gridCol>
                <a:gridCol w="1517859">
                  <a:extLst>
                    <a:ext uri="{9D8B030D-6E8A-4147-A177-3AD203B41FA5}">
                      <a16:colId xmlns:a16="http://schemas.microsoft.com/office/drawing/2014/main" val="2062478542"/>
                    </a:ext>
                  </a:extLst>
                </a:gridCol>
                <a:gridCol w="1517859">
                  <a:extLst>
                    <a:ext uri="{9D8B030D-6E8A-4147-A177-3AD203B41FA5}">
                      <a16:colId xmlns:a16="http://schemas.microsoft.com/office/drawing/2014/main" val="843388190"/>
                    </a:ext>
                  </a:extLst>
                </a:gridCol>
                <a:gridCol w="1628535">
                  <a:extLst>
                    <a:ext uri="{9D8B030D-6E8A-4147-A177-3AD203B41FA5}">
                      <a16:colId xmlns:a16="http://schemas.microsoft.com/office/drawing/2014/main" val="2483772715"/>
                    </a:ext>
                  </a:extLst>
                </a:gridCol>
                <a:gridCol w="1375558">
                  <a:extLst>
                    <a:ext uri="{9D8B030D-6E8A-4147-A177-3AD203B41FA5}">
                      <a16:colId xmlns:a16="http://schemas.microsoft.com/office/drawing/2014/main" val="311846552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Group 1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Mic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rrest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Blastocyst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Total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41388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Young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4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5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490246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g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5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60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65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780820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29896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Group 2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Mic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rrest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Blastocyst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Total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897025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Young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20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46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66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011711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g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8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59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67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784046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391104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Group 3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Mic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rrest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Blastocyst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Total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0607774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Young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29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96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125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2187549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g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3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5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8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627529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386190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Group 4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Mic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rrest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Blastocyst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Total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9902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Young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4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26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30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567686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u="none" strike="noStrike" dirty="0">
                          <a:effectLst/>
                        </a:rPr>
                        <a:t>Aged</a:t>
                      </a:r>
                      <a:endParaRPr lang="en-US" sz="2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5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>
                          <a:effectLst/>
                        </a:rPr>
                        <a:t>12</a:t>
                      </a:r>
                      <a:endParaRPr lang="en-US" sz="2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u="none" strike="noStrike" dirty="0">
                          <a:effectLst/>
                        </a:rPr>
                        <a:t>17</a:t>
                      </a:r>
                      <a:endParaRPr lang="en-US" sz="2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21103049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3874AF7-0D55-897A-144A-6E3D7056EEE1}"/>
              </a:ext>
            </a:extLst>
          </p:cNvPr>
          <p:cNvSpPr txBox="1"/>
          <p:nvPr/>
        </p:nvSpPr>
        <p:spPr>
          <a:xfrm>
            <a:off x="285750" y="247650"/>
            <a:ext cx="45236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728518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F0253F0-FC6A-AAF7-BB7C-B69FA8445DC4}"/>
              </a:ext>
            </a:extLst>
          </p:cNvPr>
          <p:cNvSpPr txBox="1"/>
          <p:nvPr/>
        </p:nvSpPr>
        <p:spPr>
          <a:xfrm>
            <a:off x="285750" y="247650"/>
            <a:ext cx="43633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18E66F9-F286-312B-5DCD-BCB3420C34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1647" y="570815"/>
            <a:ext cx="11124603" cy="5991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494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FC779C-4E04-DAAA-9EF5-4B0D86ACED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PNf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673CE-9CB6-117A-EA1A-311CB8086D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FC1715C-3C17-EFBA-DA0B-33919626AC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1456" y="1916207"/>
            <a:ext cx="4913929" cy="35737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E5E2393-3FD1-B97B-9122-540969E33FE9}"/>
              </a:ext>
            </a:extLst>
          </p:cNvPr>
          <p:cNvSpPr txBox="1"/>
          <p:nvPr/>
        </p:nvSpPr>
        <p:spPr>
          <a:xfrm>
            <a:off x="7250575" y="2147882"/>
            <a:ext cx="4578723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65          49.45</a:t>
            </a:r>
          </a:p>
          <a:p>
            <a:r>
              <a:rPr lang="en-US" sz="1350" dirty="0"/>
              <a:t>1     |        64          79.55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29         129.00</a:t>
            </a:r>
          </a:p>
          <a:p>
            <a:endParaRPr lang="en-US" sz="1350" dirty="0"/>
          </a:p>
          <a:p>
            <a:r>
              <a:rPr lang="en-US" sz="1350" dirty="0"/>
              <a:t>            chi2(1) =       8.98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2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C7B94CF-3B65-33E9-9F5F-BCFD41020BDC}"/>
              </a:ext>
            </a:extLst>
          </p:cNvPr>
          <p:cNvSpPr txBox="1"/>
          <p:nvPr/>
        </p:nvSpPr>
        <p:spPr>
          <a:xfrm>
            <a:off x="285750" y="247650"/>
            <a:ext cx="4315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343226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B9571B-3EC4-9A4D-7E55-0648A7A39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BB7471-3837-4D2F-6AA0-90D391FBFC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7C7E559-7DD1-B9BB-6094-43C10F2B8D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1115" y="2125266"/>
            <a:ext cx="4952255" cy="36016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40F69F-BA53-29AF-DC8B-7FD5D9338A17}"/>
              </a:ext>
            </a:extLst>
          </p:cNvPr>
          <p:cNvSpPr txBox="1"/>
          <p:nvPr/>
        </p:nvSpPr>
        <p:spPr>
          <a:xfrm>
            <a:off x="7104906" y="2047315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350" dirty="0"/>
          </a:p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62          52.88</a:t>
            </a:r>
          </a:p>
          <a:p>
            <a:r>
              <a:rPr lang="en-US" sz="1350" dirty="0"/>
              <a:t>1     |        63          72.12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25         125.00</a:t>
            </a:r>
          </a:p>
          <a:p>
            <a:endParaRPr lang="en-US" sz="1350" dirty="0"/>
          </a:p>
          <a:p>
            <a:r>
              <a:rPr lang="en-US" sz="1350" dirty="0"/>
              <a:t>            chi2(1) =       3.20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73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F6A3E0-FADC-3AEF-0491-34DD093202B5}"/>
              </a:ext>
            </a:extLst>
          </p:cNvPr>
          <p:cNvSpPr txBox="1"/>
          <p:nvPr/>
        </p:nvSpPr>
        <p:spPr>
          <a:xfrm>
            <a:off x="285750" y="247650"/>
            <a:ext cx="4683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1901529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1B1C6-A62B-465D-AE0C-39A7BFDAA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3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65D04FC5-CC2D-3AAC-B525-61D6134DE68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152650" y="2125266"/>
            <a:ext cx="3771900" cy="2743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7A8EB38-0A6F-9CFA-38C0-EE8741445531}"/>
              </a:ext>
            </a:extLst>
          </p:cNvPr>
          <p:cNvSpPr txBox="1"/>
          <p:nvPr/>
        </p:nvSpPr>
        <p:spPr>
          <a:xfrm>
            <a:off x="6096001" y="2147882"/>
            <a:ext cx="4578723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5          63.21</a:t>
            </a:r>
          </a:p>
          <a:p>
            <a:r>
              <a:rPr lang="en-US" sz="1350" dirty="0"/>
              <a:t>1     |        63          54.79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8         118.00</a:t>
            </a:r>
          </a:p>
          <a:p>
            <a:endParaRPr lang="en-US" sz="1350" dirty="0"/>
          </a:p>
          <a:p>
            <a:r>
              <a:rPr lang="en-US" sz="1350" dirty="0"/>
              <a:t>            chi2(1) =       2.42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120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2121DA-E25B-1F3A-B26A-FC3AA7D4040A}"/>
              </a:ext>
            </a:extLst>
          </p:cNvPr>
          <p:cNvSpPr txBox="1"/>
          <p:nvPr/>
        </p:nvSpPr>
        <p:spPr>
          <a:xfrm>
            <a:off x="285750" y="247650"/>
            <a:ext cx="4106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5119201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97624-38F9-7517-4F4E-29E3B5F38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4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298BC71-971A-77B0-E2E6-3E1D8EC44FB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324100" y="2365597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D27862F-A16C-535F-4824-C8D58D51378E}"/>
              </a:ext>
            </a:extLst>
          </p:cNvPr>
          <p:cNvSpPr txBox="1"/>
          <p:nvPr/>
        </p:nvSpPr>
        <p:spPr>
          <a:xfrm>
            <a:off x="6637245" y="2102366"/>
            <a:ext cx="4578723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5          67.37</a:t>
            </a:r>
          </a:p>
          <a:p>
            <a:r>
              <a:rPr lang="en-US" sz="1350" dirty="0"/>
              <a:t>1     |        63          50.63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8         118.00</a:t>
            </a:r>
          </a:p>
          <a:p>
            <a:endParaRPr lang="en-US" sz="1350" dirty="0"/>
          </a:p>
          <a:p>
            <a:r>
              <a:rPr lang="en-US" sz="1350" dirty="0"/>
              <a:t>            chi2(1) =       5.60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180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D1283C4-5956-C4A2-D19B-F4B0237EC004}"/>
              </a:ext>
            </a:extLst>
          </p:cNvPr>
          <p:cNvSpPr txBox="1"/>
          <p:nvPr/>
        </p:nvSpPr>
        <p:spPr>
          <a:xfrm>
            <a:off x="285750" y="247650"/>
            <a:ext cx="3962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23527357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28F27E-12AB-D6BA-4896-F3215F54B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5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8105E87-2FC9-D978-325B-74CCC4E3495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152650" y="2486621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991D203-A01A-B917-33FC-72F823148850}"/>
              </a:ext>
            </a:extLst>
          </p:cNvPr>
          <p:cNvSpPr txBox="1"/>
          <p:nvPr/>
        </p:nvSpPr>
        <p:spPr>
          <a:xfrm>
            <a:off x="6435539" y="2044005"/>
            <a:ext cx="4578723" cy="27930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3          75.05</a:t>
            </a:r>
          </a:p>
          <a:p>
            <a:r>
              <a:rPr lang="en-US" sz="1350" dirty="0"/>
              <a:t>1     |        62          39.95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5         115.00</a:t>
            </a:r>
          </a:p>
          <a:p>
            <a:endParaRPr lang="en-US" sz="1350" dirty="0"/>
          </a:p>
          <a:p>
            <a:r>
              <a:rPr lang="en-US" sz="1350" dirty="0"/>
              <a:t>            chi2(1) =      20.99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0</a:t>
            </a:r>
          </a:p>
          <a:p>
            <a:endParaRPr lang="en-US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6A5DDE5-55CB-9C3E-966A-488999DE4F96}"/>
              </a:ext>
            </a:extLst>
          </p:cNvPr>
          <p:cNvSpPr txBox="1"/>
          <p:nvPr/>
        </p:nvSpPr>
        <p:spPr>
          <a:xfrm>
            <a:off x="285750" y="247650"/>
            <a:ext cx="47641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3620131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6D893-0F9E-AD98-F642-39BCDABEE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6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0FF8F4-DE20-AF8C-E704-9551CC5480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DD60020-B8CC-154C-062A-56C9A339AF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5415" y="2057400"/>
            <a:ext cx="3771900" cy="274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536C133-159E-B6A9-0FA7-0ACA1635447B}"/>
              </a:ext>
            </a:extLst>
          </p:cNvPr>
          <p:cNvSpPr txBox="1"/>
          <p:nvPr/>
        </p:nvSpPr>
        <p:spPr>
          <a:xfrm>
            <a:off x="6334688" y="1940132"/>
            <a:ext cx="4578723" cy="30008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sz="1350" dirty="0"/>
          </a:p>
          <a:p>
            <a:r>
              <a:rPr lang="en-US" sz="1350" dirty="0"/>
              <a:t>Log-rank test for equality of survivor functions</a:t>
            </a:r>
          </a:p>
          <a:p>
            <a:endParaRPr lang="en-US" sz="1350" dirty="0"/>
          </a:p>
          <a:p>
            <a:r>
              <a:rPr lang="en-US" sz="1350" dirty="0"/>
              <a:t>      |   Events         Events</a:t>
            </a:r>
          </a:p>
          <a:p>
            <a:r>
              <a:rPr lang="en-US" sz="1350" dirty="0"/>
              <a:t>age   |  observed       expected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0     |        53          76.03</a:t>
            </a:r>
          </a:p>
          <a:p>
            <a:r>
              <a:rPr lang="en-US" sz="1350" dirty="0"/>
              <a:t>1     |        62          38.97</a:t>
            </a:r>
          </a:p>
          <a:p>
            <a:r>
              <a:rPr lang="en-US" sz="1350" dirty="0"/>
              <a:t>------+-------------------------</a:t>
            </a:r>
          </a:p>
          <a:p>
            <a:r>
              <a:rPr lang="en-US" sz="1350" dirty="0"/>
              <a:t>Total |       115         115.00</a:t>
            </a:r>
          </a:p>
          <a:p>
            <a:endParaRPr lang="en-US" sz="1350" dirty="0"/>
          </a:p>
          <a:p>
            <a:r>
              <a:rPr lang="en-US" sz="1350" dirty="0"/>
              <a:t>            chi2(1) =      22.93</a:t>
            </a:r>
          </a:p>
          <a:p>
            <a:r>
              <a:rPr lang="en-US" sz="1350" dirty="0"/>
              <a:t>            </a:t>
            </a:r>
            <a:r>
              <a:rPr lang="en-US" sz="1350" dirty="0" err="1"/>
              <a:t>Pr</a:t>
            </a:r>
            <a:r>
              <a:rPr lang="en-US" sz="1350" dirty="0"/>
              <a:t>&gt;chi2 =     0.0000</a:t>
            </a:r>
          </a:p>
          <a:p>
            <a:endParaRPr lang="en-US" sz="135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D9B27FB-2B2E-9A22-19F9-E04570D598FA}"/>
              </a:ext>
            </a:extLst>
          </p:cNvPr>
          <p:cNvSpPr txBox="1"/>
          <p:nvPr/>
        </p:nvSpPr>
        <p:spPr>
          <a:xfrm>
            <a:off x="285750" y="247650"/>
            <a:ext cx="47160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4202211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48</TotalTime>
  <Words>657</Words>
  <Application>Microsoft Macintosh PowerPoint</Application>
  <PresentationFormat>Widescreen</PresentationFormat>
  <Paragraphs>261</Paragraphs>
  <Slides>1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Supplemental File 1</vt:lpstr>
      <vt:lpstr>PowerPoint Presentation</vt:lpstr>
      <vt:lpstr>PowerPoint Presentation</vt:lpstr>
      <vt:lpstr>tPNf</vt:lpstr>
      <vt:lpstr>t2</vt:lpstr>
      <vt:lpstr>t3</vt:lpstr>
      <vt:lpstr>t4</vt:lpstr>
      <vt:lpstr>t5</vt:lpstr>
      <vt:lpstr>t6</vt:lpstr>
      <vt:lpstr>t7</vt:lpstr>
      <vt:lpstr>t8</vt:lpstr>
      <vt:lpstr>t9</vt:lpstr>
      <vt:lpstr>tM</vt:lpstr>
      <vt:lpstr>tSB</vt:lpstr>
      <vt:lpstr>tB</vt:lpstr>
      <vt:lpstr>tEB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</dc:title>
  <dc:creator>Yang, Liubin</dc:creator>
  <cp:lastModifiedBy>Yang, Liubin</cp:lastModifiedBy>
  <cp:revision>6</cp:revision>
  <dcterms:created xsi:type="dcterms:W3CDTF">2023-10-23T18:28:39Z</dcterms:created>
  <dcterms:modified xsi:type="dcterms:W3CDTF">2024-01-19T21:34:55Z</dcterms:modified>
</cp:coreProperties>
</file>